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10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ile chi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9D7B26C5-4107-4FEC-AEDC-1716B250A1EF}" styleName="Stile chiar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essuno stile, griglia tabel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947"/>
    <p:restoredTop sz="95768"/>
  </p:normalViewPr>
  <p:slideViewPr>
    <p:cSldViewPr snapToGrid="0" snapToObjects="1">
      <p:cViewPr>
        <p:scale>
          <a:sx n="60" d="100"/>
          <a:sy n="60" d="100"/>
        </p:scale>
        <p:origin x="-2064" y="282"/>
      </p:cViewPr>
      <p:guideLst>
        <p:guide orient="horz" pos="3120"/>
        <p:guide orient="horz" pos="3102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8BDB25-C5F3-D842-9344-29177B33F890}" type="datetimeFigureOut">
              <a:rPr lang="en-GB" smtClean="0"/>
              <a:t>10/07/2020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A865FEC-E874-0C4C-B074-4A755C2E287C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49957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499"/>
            </a:lvl2pPr>
            <a:lvl3pPr marL="685743" indent="0" algn="ctr">
              <a:buNone/>
              <a:defRPr sz="1351"/>
            </a:lvl3pPr>
            <a:lvl4pPr marL="1028614" indent="0" algn="ctr">
              <a:buNone/>
              <a:defRPr sz="1200"/>
            </a:lvl4pPr>
            <a:lvl5pPr marL="1371486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100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9544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7236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71567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60278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9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4134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19713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6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3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100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3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6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100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99810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73718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3183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100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2194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72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499"/>
            </a:lvl4pPr>
            <a:lvl5pPr marL="1371486" indent="0">
              <a:buNone/>
              <a:defRPr sz="1499"/>
            </a:lvl5pPr>
            <a:lvl6pPr marL="1714356" indent="0">
              <a:buNone/>
              <a:defRPr sz="1499"/>
            </a:lvl6pPr>
            <a:lvl7pPr marL="2057228" indent="0">
              <a:buNone/>
              <a:defRPr sz="1499"/>
            </a:lvl7pPr>
            <a:lvl8pPr marL="2400100" indent="0">
              <a:buNone/>
              <a:defRPr sz="1499"/>
            </a:lvl8pPr>
            <a:lvl9pPr marL="2742970" indent="0">
              <a:buNone/>
              <a:defRPr sz="1499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6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100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3258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6DF832-16AC-1D4B-8E5E-48D7E12D42DE}" type="datetimeFigureOut">
              <a:rPr lang="it-IT" smtClean="0"/>
              <a:t>10/07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272B56-C234-7645-9591-4E3B5EACB7A5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1699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8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6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100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>
            <a:extLst>
              <a:ext uri="{FF2B5EF4-FFF2-40B4-BE49-F238E27FC236}">
                <a16:creationId xmlns:a16="http://schemas.microsoft.com/office/drawing/2014/main" xmlns="" id="{C89FC334-7985-ED46-82BC-72BA80F4D07B}"/>
              </a:ext>
            </a:extLst>
          </p:cNvPr>
          <p:cNvSpPr/>
          <p:nvPr/>
        </p:nvSpPr>
        <p:spPr>
          <a:xfrm>
            <a:off x="242606" y="2606040"/>
            <a:ext cx="6372788" cy="162467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.  Time- dependent expression of </a:t>
            </a:r>
            <a:r>
              <a:rPr lang="en-US" sz="11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qo1</a:t>
            </a: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response to NRF2 activation in peritoneal macrophages. 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</a:t>
            </a:r>
            <a:r>
              <a:rPr lang="it-IT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xpression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it-IT" sz="11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qo1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was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sured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</a:t>
            </a:r>
            <a:r>
              <a:rPr lang="it-IT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itoneal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acrophages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it-IT" sz="1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reated</a:t>
            </a:r>
            <a:r>
              <a:rPr lang="it-IT" sz="1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with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 vehicle (open triangles) or increasing concentrations of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tBHQ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(1µM, filled circles; 10µM, filled triangles; 100µM, filled squares) for 3, 6 and 16 h, as indicated. Real time PCR was used to analyze the mRNA. Data set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fwere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calculated using the 2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 −</a:t>
            </a:r>
            <a:r>
              <a:rPr lang="it-IT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𝚫𝚫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Ct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thod and expressed in relation to 3h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samples. Data are presented as mean ± SEM (n=3). Results were analyzed by two-way ANOVA followed by Dunnett’s multiple comparisons test (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 0.05; (**)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 0.01 p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&lt; 0.01, (***)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versus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veh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 (F(3,24)=99.30)  </a:t>
            </a:r>
            <a:endParaRPr lang="it-IT" sz="11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endParaRPr lang="it-IT" sz="1100" i="1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xmlns="" id="{7943AB4F-7746-3148-867E-FADB59103C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606" y="490220"/>
            <a:ext cx="2883303" cy="16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146584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074</TotalTime>
  <Words>141</Words>
  <Application>Microsoft Office PowerPoint</Application>
  <PresentationFormat>A4 (21x29,7 cm)</PresentationFormat>
  <Paragraphs>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ederica mornata</dc:creator>
  <cp:lastModifiedBy>elisabetta vegeto</cp:lastModifiedBy>
  <cp:revision>230</cp:revision>
  <cp:lastPrinted>2020-06-19T14:48:30Z</cp:lastPrinted>
  <dcterms:created xsi:type="dcterms:W3CDTF">2019-05-16T13:04:22Z</dcterms:created>
  <dcterms:modified xsi:type="dcterms:W3CDTF">2020-07-10T16:45:34Z</dcterms:modified>
</cp:coreProperties>
</file>